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AD50EB1-66F0-4AEF-9129-054089EA32D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6370804-0FFE-4E03-8E27-570FD3BB45B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288707-C865-4AA1-8978-7E046F0EB46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0599F1-1CDF-4AE7-845F-26A70F7A3C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86721F-AA01-46A8-9069-0293F365A93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58A5EC-178B-460B-AFA9-0D70EA1AB3C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70F982-C052-4156-BDE7-45D969F045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1E01B3-7427-4BD6-B964-8E87C7ED04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C3BB58-55DC-445A-864B-B6BF34DDFF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6E83C0-A83C-4A2F-889E-4831C3DF0C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A68964-21FF-45E0-9CDE-30000B7390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4B4F59-1F48-48B6-9B67-D6C4D6F343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0DD69B-D734-4241-9DCA-5FB64DC166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D90345-1A5B-4504-941C-2526212668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9C7A110-8F92-432C-AD63-F3440DCD74C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920880" y="1324080"/>
            <a:ext cx="7300800" cy="500040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475920" y="262080"/>
            <a:ext cx="8394120" cy="88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2 Intron conservation and divergenc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he wheat LKR/SDH introns were concatenated into a single contiguous sequence and used to compare to the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Brachypodium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(A) and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aize (B) LKR/SDH genes from start to stop codons (exons + introns). Dot blot analyses indicated similarity using criteria of an 80%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atch over a 20 bp window. Results found only the wheat/Brachypodium comparison indicated intron sequence conservation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he wheat/maize result is similar to all other comparison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4T19:44:00Z</dcterms:created>
  <dc:creator> </dc:creator>
  <dc:description/>
  <dc:language>en-US</dc:language>
  <cp:lastModifiedBy>Office 2003 Registered User</cp:lastModifiedBy>
  <dcterms:modified xsi:type="dcterms:W3CDTF">2010-05-18T23:03:18Z</dcterms:modified>
  <cp:revision>5</cp:revision>
  <dc:subject/>
  <dc:title>Slide 1</dc:title>
</cp:coreProperties>
</file>